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7.xml" ContentType="application/vnd.openxmlformats-officedocument.presentationml.slideLayout+xml"/>
  <Override PartName="/ppt/commentAuthors.xml" ContentType="application/vnd.openxmlformats-officedocument.presentationml.commentAuthors+xml"/>
  <Override PartName="/ppt/authors.xml" ContentType="application/vnd.ms-powerpoint.authors+xml"/>
  <Override PartName="/ppt/theme/theme2.xml" ContentType="application/vnd.openxmlformats-officedocument.theme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6"/>
  </p:notesMasterIdLst>
  <p:sldIdLst>
    <p:sldId id="264" r:id="rId2"/>
    <p:sldId id="263" r:id="rId3"/>
    <p:sldId id="266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8DC3EBF-102F-2316-9DB5-C19721D00C85}" name="Eichenberg, Thea" initials="TE" userId="S::thea.eichenberg@izi.fraunhofer.de::69d505c1-7ae4-4781-8999-e7187b9d9b19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ünkel, Anna" initials="DA" lastIdx="1" clrIdx="0">
    <p:extLst>
      <p:ext uri="{19B8F6BF-5375-455C-9EA6-DF929625EA0E}">
        <p15:presenceInfo xmlns:p15="http://schemas.microsoft.com/office/powerpoint/2012/main" userId="S::anna.duenkel@izi.fraunhofer.de::389e6d3e-fe5d-4347-91b8-7bb40b548a3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506" y="-41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720438-76E9-46F8-964D-7D6099CE7084}" type="datetimeFigureOut">
              <a:rPr lang="de-DE" smtClean="0"/>
              <a:t>06.06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5B1FD8-6299-4AD8-9F1F-8B75B11C93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8735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0812-1549-429D-B520-D5A70A301F10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78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7873C-DB84-4E4E-B37C-7852F7F06B78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19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6E2D-45E0-4F86-9A12-405D29F6BFBC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873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7873-588F-4D4E-A307-9802EB68A555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909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263E2-A8DD-4DFA-8B64-BFF2B4D73BDD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8890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A4D9-D3F4-4D84-AB33-DFDD4AA40789}" type="datetime1">
              <a:rPr lang="de-DE" smtClean="0"/>
              <a:t>06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37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DB409-0898-4735-8DCC-E53841FB96BC}" type="datetime1">
              <a:rPr lang="de-DE" smtClean="0"/>
              <a:t>06.06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919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625AF-1666-4C3E-A40C-B19FBA4A2600}" type="datetime1">
              <a:rPr lang="de-DE" smtClean="0"/>
              <a:t>06.06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701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0EB6-1FE4-4B7E-BAB5-78BFA6C2AC69}" type="datetime1">
              <a:rPr lang="de-DE" smtClean="0"/>
              <a:t>06.06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320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531E3-7A1C-4C1E-9B7E-7F3221FFD598}" type="datetime1">
              <a:rPr lang="de-DE" smtClean="0"/>
              <a:t>06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286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FF179-BF33-426F-9C49-B111CF480FE2}" type="datetime1">
              <a:rPr lang="de-DE" smtClean="0"/>
              <a:t>06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239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C0B34-E21A-4874-89B1-2D26B2491B41}" type="datetime1">
              <a:rPr lang="de-DE" smtClean="0"/>
              <a:t>06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44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6B74D667-ADCE-47F5-BAE1-571CE0FA32FD}"/>
              </a:ext>
            </a:extLst>
          </p:cNvPr>
          <p:cNvSpPr txBox="1"/>
          <p:nvPr/>
        </p:nvSpPr>
        <p:spPr>
          <a:xfrm>
            <a:off x="339194" y="631043"/>
            <a:ext cx="525175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1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immune status) of NK cells from donor 5 prior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after NK cell isolation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Grafik 34">
            <a:extLst>
              <a:ext uri="{FF2B5EF4-FFF2-40B4-BE49-F238E27FC236}">
                <a16:creationId xmlns:a16="http://schemas.microsoft.com/office/drawing/2014/main" id="{A2617F01-0C79-4BB7-99DE-E486624879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1" y="4386716"/>
            <a:ext cx="3321488" cy="4439542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4253D7B0-F9CD-4AEA-8C4D-D6109F4FEB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2754" y="4345493"/>
            <a:ext cx="3321488" cy="4439540"/>
          </a:xfrm>
          <a:prstGeom prst="rect">
            <a:avLst/>
          </a:prstGeom>
        </p:spPr>
      </p:pic>
      <p:sp>
        <p:nvSpPr>
          <p:cNvPr id="37" name="Textfeld 36">
            <a:extLst>
              <a:ext uri="{FF2B5EF4-FFF2-40B4-BE49-F238E27FC236}">
                <a16:creationId xmlns:a16="http://schemas.microsoft.com/office/drawing/2014/main" id="{9DC6B27E-CFE9-47B8-88B2-A6421DC46CDF}"/>
              </a:ext>
            </a:extLst>
          </p:cNvPr>
          <p:cNvSpPr txBox="1"/>
          <p:nvPr/>
        </p:nvSpPr>
        <p:spPr>
          <a:xfrm>
            <a:off x="209351" y="8931880"/>
            <a:ext cx="5668539" cy="5599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Figure 1: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Determination of purity by flow cytometry (immune status) of NK cells from donor 5</a:t>
            </a:r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	A: Prior NK </a:t>
            </a:r>
            <a:r>
              <a:rPr lang="de-DE" sz="1013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13" dirty="0" err="1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  <a:endParaRPr lang="de-DE" sz="101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	B: After NK </a:t>
            </a:r>
            <a:r>
              <a:rPr lang="de-DE" sz="1013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13" dirty="0" err="1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  <a:endParaRPr lang="de-DE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4CF3CBDB-E2EF-4251-BA31-8D955397AEA7}"/>
              </a:ext>
            </a:extLst>
          </p:cNvPr>
          <p:cNvCxnSpPr>
            <a:cxnSpLocks/>
          </p:cNvCxnSpPr>
          <p:nvPr/>
        </p:nvCxnSpPr>
        <p:spPr>
          <a:xfrm>
            <a:off x="3375243" y="4105804"/>
            <a:ext cx="0" cy="45259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0A4F2D5B-7C36-427B-9A4F-B00CC7B99A4C}"/>
              </a:ext>
            </a:extLst>
          </p:cNvPr>
          <p:cNvSpPr txBox="1"/>
          <p:nvPr/>
        </p:nvSpPr>
        <p:spPr>
          <a:xfrm>
            <a:off x="3820193" y="3980128"/>
            <a:ext cx="30378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) After NK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2A0228B8-109A-447B-BDD8-AA249F8F1745}"/>
              </a:ext>
            </a:extLst>
          </p:cNvPr>
          <p:cNvSpPr txBox="1"/>
          <p:nvPr/>
        </p:nvSpPr>
        <p:spPr>
          <a:xfrm>
            <a:off x="188393" y="3988620"/>
            <a:ext cx="3240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) Prior NK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6EECCA81-3F51-4E7C-BB1D-1128F0C5B83E}"/>
              </a:ext>
            </a:extLst>
          </p:cNvPr>
          <p:cNvSpPr txBox="1"/>
          <p:nvPr/>
        </p:nvSpPr>
        <p:spPr>
          <a:xfrm>
            <a:off x="784856" y="4443902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1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5536DDC6-64BA-4C0C-8132-43B034F416CD}"/>
              </a:ext>
            </a:extLst>
          </p:cNvPr>
          <p:cNvSpPr txBox="1"/>
          <p:nvPr/>
        </p:nvSpPr>
        <p:spPr>
          <a:xfrm>
            <a:off x="1844254" y="4422657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2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BC95173-462C-4EFF-8BE3-A1461028272B}"/>
              </a:ext>
            </a:extLst>
          </p:cNvPr>
          <p:cNvSpPr txBox="1"/>
          <p:nvPr/>
        </p:nvSpPr>
        <p:spPr>
          <a:xfrm>
            <a:off x="3002815" y="4445110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3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96BD6E90-313B-42FA-897A-9348FB45599F}"/>
              </a:ext>
            </a:extLst>
          </p:cNvPr>
          <p:cNvSpPr txBox="1"/>
          <p:nvPr/>
        </p:nvSpPr>
        <p:spPr>
          <a:xfrm>
            <a:off x="822798" y="5539315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4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C4A8F018-1BA2-4B21-9794-FD727A9E3C9C}"/>
              </a:ext>
            </a:extLst>
          </p:cNvPr>
          <p:cNvSpPr txBox="1"/>
          <p:nvPr/>
        </p:nvSpPr>
        <p:spPr>
          <a:xfrm>
            <a:off x="1880780" y="5640699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5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2AC5C449-02A3-4FC7-8E72-3506C2BF389E}"/>
              </a:ext>
            </a:extLst>
          </p:cNvPr>
          <p:cNvSpPr txBox="1"/>
          <p:nvPr/>
        </p:nvSpPr>
        <p:spPr>
          <a:xfrm>
            <a:off x="2985745" y="5612919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6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4EAB5DD9-B97C-4F27-8A4D-4277509423B0}"/>
              </a:ext>
            </a:extLst>
          </p:cNvPr>
          <p:cNvSpPr txBox="1"/>
          <p:nvPr/>
        </p:nvSpPr>
        <p:spPr>
          <a:xfrm>
            <a:off x="820952" y="6731723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0508BBA6-069B-44E3-90CB-F04EB70B2186}"/>
              </a:ext>
            </a:extLst>
          </p:cNvPr>
          <p:cNvSpPr txBox="1"/>
          <p:nvPr/>
        </p:nvSpPr>
        <p:spPr>
          <a:xfrm>
            <a:off x="1894476" y="6726010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8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17C83F2F-F308-45E3-A8AD-4E3B680CA2E9}"/>
              </a:ext>
            </a:extLst>
          </p:cNvPr>
          <p:cNvSpPr txBox="1"/>
          <p:nvPr/>
        </p:nvSpPr>
        <p:spPr>
          <a:xfrm>
            <a:off x="3002815" y="6780140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9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31DBEF8A-DDBC-40AE-BDA6-E9F6DDB7A8FE}"/>
              </a:ext>
            </a:extLst>
          </p:cNvPr>
          <p:cNvSpPr txBox="1"/>
          <p:nvPr/>
        </p:nvSpPr>
        <p:spPr>
          <a:xfrm>
            <a:off x="748340" y="7827136"/>
            <a:ext cx="3914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10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553054E8-3F00-40B8-AB0E-B0F20528A487}"/>
              </a:ext>
            </a:extLst>
          </p:cNvPr>
          <p:cNvSpPr txBox="1"/>
          <p:nvPr/>
        </p:nvSpPr>
        <p:spPr>
          <a:xfrm>
            <a:off x="4314195" y="4422657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FA800486-C20D-4E6B-AE5A-3DA48385C7B0}"/>
              </a:ext>
            </a:extLst>
          </p:cNvPr>
          <p:cNvSpPr txBox="1"/>
          <p:nvPr/>
        </p:nvSpPr>
        <p:spPr>
          <a:xfrm>
            <a:off x="5298344" y="4403097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2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8204AD78-BD54-4E1A-BAE7-FF66F0B1D007}"/>
              </a:ext>
            </a:extLst>
          </p:cNvPr>
          <p:cNvSpPr txBox="1"/>
          <p:nvPr/>
        </p:nvSpPr>
        <p:spPr>
          <a:xfrm>
            <a:off x="6477739" y="4423657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3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02C76AA8-4350-488B-B93E-EC574188CB8E}"/>
              </a:ext>
            </a:extLst>
          </p:cNvPr>
          <p:cNvSpPr txBox="1"/>
          <p:nvPr/>
        </p:nvSpPr>
        <p:spPr>
          <a:xfrm>
            <a:off x="4282869" y="5528136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4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C4ABF4E0-7060-4816-9E74-88D35811E37F}"/>
              </a:ext>
            </a:extLst>
          </p:cNvPr>
          <p:cNvSpPr txBox="1"/>
          <p:nvPr/>
        </p:nvSpPr>
        <p:spPr>
          <a:xfrm>
            <a:off x="5340851" y="5663895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74088321-B6DC-4F30-89C5-72A2B707CB68}"/>
              </a:ext>
            </a:extLst>
          </p:cNvPr>
          <p:cNvSpPr txBox="1"/>
          <p:nvPr/>
        </p:nvSpPr>
        <p:spPr>
          <a:xfrm>
            <a:off x="6456244" y="5551500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6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EAFA873C-D78D-4630-B872-E124B2491B09}"/>
              </a:ext>
            </a:extLst>
          </p:cNvPr>
          <p:cNvSpPr txBox="1"/>
          <p:nvPr/>
        </p:nvSpPr>
        <p:spPr>
          <a:xfrm>
            <a:off x="4282869" y="6715373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7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FCD2DFA2-4C8E-4A79-BEFA-23DAB27DDC92}"/>
              </a:ext>
            </a:extLst>
          </p:cNvPr>
          <p:cNvSpPr txBox="1"/>
          <p:nvPr/>
        </p:nvSpPr>
        <p:spPr>
          <a:xfrm>
            <a:off x="5353773" y="6660355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8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AFF2B26D-09FF-442A-A9A9-0C3197E5AD8C}"/>
              </a:ext>
            </a:extLst>
          </p:cNvPr>
          <p:cNvSpPr txBox="1"/>
          <p:nvPr/>
        </p:nvSpPr>
        <p:spPr>
          <a:xfrm>
            <a:off x="6477739" y="6726010"/>
            <a:ext cx="31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9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A4287212-7A03-4F23-978A-A3074B3F94C2}"/>
              </a:ext>
            </a:extLst>
          </p:cNvPr>
          <p:cNvSpPr txBox="1"/>
          <p:nvPr/>
        </p:nvSpPr>
        <p:spPr>
          <a:xfrm>
            <a:off x="4260012" y="7794888"/>
            <a:ext cx="3779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10</a:t>
            </a:r>
          </a:p>
        </p:txBody>
      </p:sp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CDEA5B40-4CD4-4C24-93AB-70D15749B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4905949"/>
              </p:ext>
            </p:extLst>
          </p:nvPr>
        </p:nvGraphicFramePr>
        <p:xfrm>
          <a:off x="417731" y="1079742"/>
          <a:ext cx="5915024" cy="26117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9713">
                  <a:extLst>
                    <a:ext uri="{9D8B030D-6E8A-4147-A177-3AD203B41FA5}">
                      <a16:colId xmlns:a16="http://schemas.microsoft.com/office/drawing/2014/main" val="3562479482"/>
                    </a:ext>
                  </a:extLst>
                </a:gridCol>
                <a:gridCol w="2466138">
                  <a:extLst>
                    <a:ext uri="{9D8B030D-6E8A-4147-A177-3AD203B41FA5}">
                      <a16:colId xmlns:a16="http://schemas.microsoft.com/office/drawing/2014/main" val="1981566307"/>
                    </a:ext>
                  </a:extLst>
                </a:gridCol>
                <a:gridCol w="1399951">
                  <a:extLst>
                    <a:ext uri="{9D8B030D-6E8A-4147-A177-3AD203B41FA5}">
                      <a16:colId xmlns:a16="http://schemas.microsoft.com/office/drawing/2014/main" val="2974222837"/>
                    </a:ext>
                  </a:extLst>
                </a:gridCol>
                <a:gridCol w="1409222">
                  <a:extLst>
                    <a:ext uri="{9D8B030D-6E8A-4147-A177-3AD203B41FA5}">
                      <a16:colId xmlns:a16="http://schemas.microsoft.com/office/drawing/2014/main" val="1219995209"/>
                    </a:ext>
                  </a:extLst>
                </a:gridCol>
              </a:tblGrid>
              <a:tr h="370461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s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or NKC isolation</a:t>
                      </a:r>
                      <a:b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D0]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NKC isolation</a:t>
                      </a:r>
                      <a:b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D0]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ctr"/>
                </a:tc>
                <a:extLst>
                  <a:ext uri="{0D108BD9-81ED-4DB2-BD59-A6C34878D82A}">
                    <a16:rowId xmlns:a16="http://schemas.microsoft.com/office/drawing/2014/main" val="3745706505"/>
                  </a:ext>
                </a:extLst>
              </a:tr>
              <a:tr h="194492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↓/sample→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 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ctr"/>
                </a:tc>
                <a:extLst>
                  <a:ext uri="{0D108BD9-81ED-4DB2-BD59-A6C34878D82A}">
                    <a16:rowId xmlns:a16="http://schemas.microsoft.com/office/drawing/2014/main" val="1756496340"/>
                  </a:ext>
                </a:extLst>
              </a:tr>
              <a:tr h="185230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8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1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2670843346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t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8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3710545759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3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0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4041253614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4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5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1353020742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8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2544101711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4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3338564261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6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9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3937777930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6+ CD56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3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452135103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9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266502263"/>
                  </a:ext>
                </a:extLst>
              </a:tr>
              <a:tr h="18523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45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4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3756199234"/>
                  </a:ext>
                </a:extLst>
              </a:tr>
              <a:tr h="19449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56+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0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262" marR="9262" marT="9262" marB="0" anchor="b"/>
                </a:tc>
                <a:extLst>
                  <a:ext uri="{0D108BD9-81ED-4DB2-BD59-A6C34878D82A}">
                    <a16:rowId xmlns:a16="http://schemas.microsoft.com/office/drawing/2014/main" val="1098356836"/>
                  </a:ext>
                </a:extLst>
              </a:tr>
            </a:tbl>
          </a:graphicData>
        </a:graphic>
      </p:graphicFrame>
      <p:sp>
        <p:nvSpPr>
          <p:cNvPr id="8" name="Foliennummernplatzhalter 7">
            <a:extLst>
              <a:ext uri="{FF2B5EF4-FFF2-40B4-BE49-F238E27FC236}">
                <a16:creationId xmlns:a16="http://schemas.microsoft.com/office/drawing/2014/main" id="{BAC9B1CC-742A-4072-82A6-D4A449B50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630" y="9180577"/>
            <a:ext cx="1543050" cy="527403"/>
          </a:xfrm>
        </p:spPr>
        <p:txBody>
          <a:bodyPr/>
          <a:lstStyle/>
          <a:p>
            <a:fld id="{7CA16D49-2449-4109-BE83-049B41A6F977}" type="slidenum">
              <a:rPr lang="de-DE" smtClean="0"/>
              <a:t>1</a:t>
            </a:fld>
            <a:endParaRPr lang="de-DE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52C0364B-886D-42EF-98DE-132392AB9B93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5: Flow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962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4ABFD6BD-5CD6-4D88-9836-89D4843724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6405452"/>
              </p:ext>
            </p:extLst>
          </p:nvPr>
        </p:nvGraphicFramePr>
        <p:xfrm>
          <a:off x="602729" y="1308401"/>
          <a:ext cx="3543299" cy="28765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3368">
                  <a:extLst>
                    <a:ext uri="{9D8B030D-6E8A-4147-A177-3AD203B41FA5}">
                      <a16:colId xmlns:a16="http://schemas.microsoft.com/office/drawing/2014/main" val="966029854"/>
                    </a:ext>
                  </a:extLst>
                </a:gridCol>
                <a:gridCol w="1660325">
                  <a:extLst>
                    <a:ext uri="{9D8B030D-6E8A-4147-A177-3AD203B41FA5}">
                      <a16:colId xmlns:a16="http://schemas.microsoft.com/office/drawing/2014/main" val="742032877"/>
                    </a:ext>
                  </a:extLst>
                </a:gridCol>
                <a:gridCol w="1119606">
                  <a:extLst>
                    <a:ext uri="{9D8B030D-6E8A-4147-A177-3AD203B41FA5}">
                      <a16:colId xmlns:a16="http://schemas.microsoft.com/office/drawing/2014/main" val="1390994268"/>
                    </a:ext>
                  </a:extLst>
                </a:gridCol>
              </a:tblGrid>
              <a:tr h="57150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s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NKC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ivation</a:t>
                      </a:r>
                      <a:b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D21]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3990182"/>
                  </a:ext>
                </a:extLst>
              </a:tr>
              <a:tr h="20002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↓/sample→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[%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9019309"/>
                  </a:ext>
                </a:extLst>
              </a:tr>
              <a:tr h="190500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56392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t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25341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3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14768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4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747548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8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0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71865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14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13971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1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9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48966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16+ CD5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6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7330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19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540364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45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6534634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cocytes CD5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2627396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4EC5EDD5-92B0-4C00-86BC-FF5C4BBA641F}"/>
              </a:ext>
            </a:extLst>
          </p:cNvPr>
          <p:cNvSpPr txBox="1"/>
          <p:nvPr/>
        </p:nvSpPr>
        <p:spPr>
          <a:xfrm>
            <a:off x="65756" y="904316"/>
            <a:ext cx="648446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2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mmune statu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f NK cells from donor 5 after NK cell expansion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hase (day 21)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A6FFC4E1-36F6-4C27-96E4-F15BBA79F3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615495"/>
              </p:ext>
            </p:extLst>
          </p:nvPr>
        </p:nvGraphicFramePr>
        <p:xfrm>
          <a:off x="715763" y="5400675"/>
          <a:ext cx="4889500" cy="30670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991">
                  <a:extLst>
                    <a:ext uri="{9D8B030D-6E8A-4147-A177-3AD203B41FA5}">
                      <a16:colId xmlns:a16="http://schemas.microsoft.com/office/drawing/2014/main" val="357068663"/>
                    </a:ext>
                  </a:extLst>
                </a:gridCol>
                <a:gridCol w="1659505">
                  <a:extLst>
                    <a:ext uri="{9D8B030D-6E8A-4147-A177-3AD203B41FA5}">
                      <a16:colId xmlns:a16="http://schemas.microsoft.com/office/drawing/2014/main" val="1640766952"/>
                    </a:ext>
                  </a:extLst>
                </a:gridCol>
                <a:gridCol w="1106337">
                  <a:extLst>
                    <a:ext uri="{9D8B030D-6E8A-4147-A177-3AD203B41FA5}">
                      <a16:colId xmlns:a16="http://schemas.microsoft.com/office/drawing/2014/main" val="1982172897"/>
                    </a:ext>
                  </a:extLst>
                </a:gridCol>
                <a:gridCol w="1360667">
                  <a:extLst>
                    <a:ext uri="{9D8B030D-6E8A-4147-A177-3AD203B41FA5}">
                      <a16:colId xmlns:a16="http://schemas.microsoft.com/office/drawing/2014/main" val="2049267647"/>
                    </a:ext>
                  </a:extLst>
                </a:gridCol>
              </a:tblGrid>
              <a:tr h="57150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ss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 NK cell expansion</a:t>
                      </a:r>
                      <a:b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D0]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 of NK cell expansion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D21]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2339994"/>
                  </a:ext>
                </a:extLst>
              </a:tr>
              <a:tr h="20002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↓/sample→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 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 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7343052"/>
                  </a:ext>
                </a:extLst>
              </a:tr>
              <a:tr h="190500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9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3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004444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t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1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703965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7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199187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913378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dim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4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9815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high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5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216215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CD1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2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558154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DNAM1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2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7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121878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NKG2D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7926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NKp30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44458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NKp44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2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8385731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 CD56+ NKp46+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097139"/>
                  </a:ext>
                </a:extLst>
              </a:tr>
            </a:tbl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0254A6FC-FC13-4F34-8485-2D03B583A859}"/>
              </a:ext>
            </a:extLst>
          </p:cNvPr>
          <p:cNvSpPr txBox="1"/>
          <p:nvPr/>
        </p:nvSpPr>
        <p:spPr>
          <a:xfrm>
            <a:off x="160509" y="4800511"/>
            <a:ext cx="6291091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3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f NK cells from donor 5 prior (day 0) and after NK cell expansion phase (day 21)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E6BF45C-8F45-41A6-9A9A-F93427D3F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2</a:t>
            </a:fld>
            <a:endParaRPr lang="de-DE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C718BB41-F810-4284-85F3-F950CC3D3C03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5: Flow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90742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29CABD03-6526-451F-BF71-59F6EA82B98A}"/>
              </a:ext>
            </a:extLst>
          </p:cNvPr>
          <p:cNvSpPr txBox="1"/>
          <p:nvPr/>
        </p:nvSpPr>
        <p:spPr>
          <a:xfrm>
            <a:off x="139012" y="587600"/>
            <a:ext cx="668748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4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n las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 - 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mmun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haustion</a:t>
            </a:r>
            <a:endParaRPr lang="de-DE" sz="1100" dirty="0">
              <a:solidFill>
                <a:srgbClr val="FF0000"/>
              </a:solidFill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DD49F226-739A-4134-9FF7-58D60392A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3</a:t>
            </a:fld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CED15AB5-5959-4861-BBB8-81EC2548832E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5: Flow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D63E6FEA-F190-42B6-9159-6AB2C6C42D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4098861"/>
              </p:ext>
            </p:extLst>
          </p:nvPr>
        </p:nvGraphicFramePr>
        <p:xfrm>
          <a:off x="248452" y="1130618"/>
          <a:ext cx="6310313" cy="34441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21420">
                  <a:extLst>
                    <a:ext uri="{9D8B030D-6E8A-4147-A177-3AD203B41FA5}">
                      <a16:colId xmlns:a16="http://schemas.microsoft.com/office/drawing/2014/main" val="747025588"/>
                    </a:ext>
                  </a:extLst>
                </a:gridCol>
                <a:gridCol w="918634">
                  <a:extLst>
                    <a:ext uri="{9D8B030D-6E8A-4147-A177-3AD203B41FA5}">
                      <a16:colId xmlns:a16="http://schemas.microsoft.com/office/drawing/2014/main" val="1640028897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3842857634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677015766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3732240179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848096741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959510226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059411397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3088038590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577328802"/>
                    </a:ext>
                  </a:extLst>
                </a:gridCol>
                <a:gridCol w="452251">
                  <a:extLst>
                    <a:ext uri="{9D8B030D-6E8A-4147-A177-3AD203B41FA5}">
                      <a16:colId xmlns:a16="http://schemas.microsoft.com/office/drawing/2014/main" val="2847813128"/>
                    </a:ext>
                  </a:extLst>
                </a:gridCol>
              </a:tblGrid>
              <a:tr h="132426">
                <a:tc gridSpan="11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cytometry [% gated] after 3 d cultivation in appropriate vess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9219457"/>
                  </a:ext>
                </a:extLst>
              </a:tr>
              <a:tr h="13242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1053963"/>
                  </a:ext>
                </a:extLst>
              </a:tr>
              <a:tr h="139047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sel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Rex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B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Rex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B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Rex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B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9889332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Immunstatus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645862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0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6773646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a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8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6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5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5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5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7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9311797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4102492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+ CD5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4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8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5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2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3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5288250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8440373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5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3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7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9195107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1434510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pto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4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2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2409096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dim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3203231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high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7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4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3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1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7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8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2488125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DNAM1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6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1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5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9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0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2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3506102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G2D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6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0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2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1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1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212069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30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4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3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8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6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1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0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1576716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4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6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1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3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3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3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8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8712335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5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4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5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2649541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Exhaustio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CD16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0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4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4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6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5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0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1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5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0396403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LAG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2686356"/>
                  </a:ext>
                </a:extLst>
              </a:tr>
              <a:tr h="132426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PD1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9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2474924"/>
                  </a:ext>
                </a:extLst>
              </a:tr>
              <a:tr h="139047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Tim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3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5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2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9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2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5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2302603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E675738C-11DF-434C-912C-9CC88D1FFF65}"/>
              </a:ext>
            </a:extLst>
          </p:cNvPr>
          <p:cNvSpPr txBox="1"/>
          <p:nvPr/>
        </p:nvSpPr>
        <p:spPr>
          <a:xfrm>
            <a:off x="248452" y="4920661"/>
            <a:ext cx="65291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5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ane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ipm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sz="1100" dirty="0">
              <a:solidFill>
                <a:srgbClr val="FF0000"/>
              </a:solidFill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127F9E18-543F-421B-B4DA-3477C32E09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6942546"/>
              </p:ext>
            </p:extLst>
          </p:nvPr>
        </p:nvGraphicFramePr>
        <p:xfrm>
          <a:off x="289129" y="5251404"/>
          <a:ext cx="5117135" cy="41889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9806">
                  <a:extLst>
                    <a:ext uri="{9D8B030D-6E8A-4147-A177-3AD203B41FA5}">
                      <a16:colId xmlns:a16="http://schemas.microsoft.com/office/drawing/2014/main" val="2088580903"/>
                    </a:ext>
                  </a:extLst>
                </a:gridCol>
                <a:gridCol w="1042576">
                  <a:extLst>
                    <a:ext uri="{9D8B030D-6E8A-4147-A177-3AD203B41FA5}">
                      <a16:colId xmlns:a16="http://schemas.microsoft.com/office/drawing/2014/main" val="535252094"/>
                    </a:ext>
                  </a:extLst>
                </a:gridCol>
                <a:gridCol w="936191">
                  <a:extLst>
                    <a:ext uri="{9D8B030D-6E8A-4147-A177-3AD203B41FA5}">
                      <a16:colId xmlns:a16="http://schemas.microsoft.com/office/drawing/2014/main" val="1480761062"/>
                    </a:ext>
                  </a:extLst>
                </a:gridCol>
                <a:gridCol w="1148962">
                  <a:extLst>
                    <a:ext uri="{9D8B030D-6E8A-4147-A177-3AD203B41FA5}">
                      <a16:colId xmlns:a16="http://schemas.microsoft.com/office/drawing/2014/main" val="2352761457"/>
                    </a:ext>
                  </a:extLst>
                </a:gridCol>
                <a:gridCol w="1159600">
                  <a:extLst>
                    <a:ext uri="{9D8B030D-6E8A-4147-A177-3AD203B41FA5}">
                      <a16:colId xmlns:a16="http://schemas.microsoft.com/office/drawing/2014/main" val="1835713471"/>
                    </a:ext>
                  </a:extLst>
                </a:gridCol>
              </a:tblGrid>
              <a:tr h="646291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el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ubator</a:t>
                      </a:r>
                      <a:b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Rex 6 [control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ubator</a:t>
                      </a:r>
                      <a:b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a-DK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box</a:t>
                      </a:r>
                      <a:b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a-DK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159176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status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+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3942523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8155955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a+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2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4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0572753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7627641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+ CD56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7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2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4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3469301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5031060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2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0415227"/>
                  </a:ext>
                </a:extLst>
              </a:tr>
              <a:tr h="175536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4545778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ptor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0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1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3955971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dim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6364494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high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8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6421687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CD16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6608458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DNAM1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7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7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6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108658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G2D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9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2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9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3409907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30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0385899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4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3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5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0422082"/>
                  </a:ext>
                </a:extLst>
              </a:tr>
              <a:tr h="175536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6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1421198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haustio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CD16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6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7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4337712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LAG3+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1063442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PD1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889616"/>
                  </a:ext>
                </a:extLst>
              </a:tr>
              <a:tr h="175536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Tim3+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79" marR="7979" marT="79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55652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22899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feld 22">
            <a:extLst>
              <a:ext uri="{FF2B5EF4-FFF2-40B4-BE49-F238E27FC236}">
                <a16:creationId xmlns:a16="http://schemas.microsoft.com/office/drawing/2014/main" id="{3CD075F9-9618-49EB-8E7A-A786AB849CD4}"/>
              </a:ext>
            </a:extLst>
          </p:cNvPr>
          <p:cNvSpPr txBox="1"/>
          <p:nvPr/>
        </p:nvSpPr>
        <p:spPr>
          <a:xfrm>
            <a:off x="97972" y="819169"/>
            <a:ext cx="65291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able 6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aw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Cellbox™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i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v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G-Rex® 24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yste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sz="1100" dirty="0">
              <a:solidFill>
                <a:srgbClr val="FF0000"/>
              </a:solidFill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237F192B-0995-472C-A616-D395BB1DA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4</a:t>
            </a:fld>
            <a:endParaRPr lang="de-DE"/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8B19DE5F-50C3-4265-B5F5-53F32BD942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5983337"/>
              </p:ext>
            </p:extLst>
          </p:nvPr>
        </p:nvGraphicFramePr>
        <p:xfrm>
          <a:off x="289129" y="1395381"/>
          <a:ext cx="5915025" cy="39341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9016">
                  <a:extLst>
                    <a:ext uri="{9D8B030D-6E8A-4147-A177-3AD203B41FA5}">
                      <a16:colId xmlns:a16="http://schemas.microsoft.com/office/drawing/2014/main" val="1439399825"/>
                    </a:ext>
                  </a:extLst>
                </a:gridCol>
                <a:gridCol w="1011222">
                  <a:extLst>
                    <a:ext uri="{9D8B030D-6E8A-4147-A177-3AD203B41FA5}">
                      <a16:colId xmlns:a16="http://schemas.microsoft.com/office/drawing/2014/main" val="361406710"/>
                    </a:ext>
                  </a:extLst>
                </a:gridCol>
                <a:gridCol w="828952">
                  <a:extLst>
                    <a:ext uri="{9D8B030D-6E8A-4147-A177-3AD203B41FA5}">
                      <a16:colId xmlns:a16="http://schemas.microsoft.com/office/drawing/2014/main" val="718574297"/>
                    </a:ext>
                  </a:extLst>
                </a:gridCol>
                <a:gridCol w="1078637">
                  <a:extLst>
                    <a:ext uri="{9D8B030D-6E8A-4147-A177-3AD203B41FA5}">
                      <a16:colId xmlns:a16="http://schemas.microsoft.com/office/drawing/2014/main" val="2012200508"/>
                    </a:ext>
                  </a:extLst>
                </a:gridCol>
                <a:gridCol w="1108599">
                  <a:extLst>
                    <a:ext uri="{9D8B030D-6E8A-4147-A177-3AD203B41FA5}">
                      <a16:colId xmlns:a16="http://schemas.microsoft.com/office/drawing/2014/main" val="77208222"/>
                    </a:ext>
                  </a:extLst>
                </a:gridCol>
                <a:gridCol w="1108599">
                  <a:extLst>
                    <a:ext uri="{9D8B030D-6E8A-4147-A177-3AD203B41FA5}">
                      <a16:colId xmlns:a16="http://schemas.microsoft.com/office/drawing/2014/main" val="1575643543"/>
                    </a:ext>
                  </a:extLst>
                </a:gridCol>
              </a:tblGrid>
              <a:tr h="606989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el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ed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awed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K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d recultivated thawed NK cells </a:t>
                      </a:r>
                      <a:b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to G-Rex 24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ed Cellbox</a:t>
                      </a:r>
                      <a:b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a-DK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</a:t>
                      </a:r>
                      <a:endParaRPr lang="da-DK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d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ltivaed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K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m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ellbox</a:t>
                      </a:r>
                      <a:b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842224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status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6864425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d</a:t>
                      </a:r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3470786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a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7452087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894416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+ CD56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7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0842127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4917320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4850610"/>
                  </a:ext>
                </a:extLst>
              </a:tr>
              <a:tr h="16486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30596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pto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6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1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0993601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dim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414173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 high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8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9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853886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CD1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2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8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8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6016575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DNAM1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9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9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6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8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4319752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G2D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0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9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1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6614494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30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4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8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925201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4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1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3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5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7079908"/>
                  </a:ext>
                </a:extLst>
              </a:tr>
              <a:tr h="16486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NKp4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1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7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353203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haustio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CD16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8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9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0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1318707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gated]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LAG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6295161"/>
                  </a:ext>
                </a:extLst>
              </a:tr>
              <a:tr h="157368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PD1+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759247"/>
                  </a:ext>
                </a:extLst>
              </a:tr>
              <a:tr h="16486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+ Tim3+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0115717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1A7B609F-8D49-4C26-80AB-31D23EEFF0D3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5: Flow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6585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786679552C1A8E4993CBF6A23FAB2ED5" ma:contentTypeVersion="4" ma:contentTypeDescription="Ein neues Dokument erstellen." ma:contentTypeScope="" ma:versionID="1242b213505befe49d9e9c581dcaf711">
  <xsd:schema xmlns:xsd="http://www.w3.org/2001/XMLSchema" xmlns:xs="http://www.w3.org/2001/XMLSchema" xmlns:p="http://schemas.microsoft.com/office/2006/metadata/properties" xmlns:ns2="92c20cd1-3e4f-4a24-813b-8bbcc542bd4a" targetNamespace="http://schemas.microsoft.com/office/2006/metadata/properties" ma:root="true" ma:fieldsID="d2993d4b4c0543e65e074508ffe52722" ns2:_="">
    <xsd:import namespace="92c20cd1-3e4f-4a24-813b-8bbcc542bd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c20cd1-3e4f-4a24-813b-8bbcc542b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2A0067F-28B0-4D01-9849-FBC0B3965686}"/>
</file>

<file path=customXml/itemProps2.xml><?xml version="1.0" encoding="utf-8"?>
<ds:datastoreItem xmlns:ds="http://schemas.openxmlformats.org/officeDocument/2006/customXml" ds:itemID="{88FB1FC7-E752-4907-A834-FB0023C28950}"/>
</file>

<file path=customXml/itemProps3.xml><?xml version="1.0" encoding="utf-8"?>
<ds:datastoreItem xmlns:ds="http://schemas.openxmlformats.org/officeDocument/2006/customXml" ds:itemID="{F407B999-CADD-4DF6-A7BC-0E239835E16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73</Words>
  <Application>Microsoft Office PowerPoint</Application>
  <PresentationFormat>A4-Papier (210 x 297 mm)</PresentationFormat>
  <Paragraphs>628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ünkel, Anna</dc:creator>
  <cp:lastModifiedBy>Roßbach, Lutz</cp:lastModifiedBy>
  <cp:revision>126</cp:revision>
  <dcterms:created xsi:type="dcterms:W3CDTF">2024-08-07T11:10:13Z</dcterms:created>
  <dcterms:modified xsi:type="dcterms:W3CDTF">2025-06-06T11:29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6679552C1A8E4993CBF6A23FAB2ED5</vt:lpwstr>
  </property>
</Properties>
</file>